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576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17F01474-2883-4616-A733-49F6D4E094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3E396FB7-A732-4407-836D-00D5AEC7413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9B4089CC-9314-4A63-B1F1-D5F82D790B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F00FCFD-5EF9-4C90-94AA-8E4C295A8C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1B5933C-B5C2-4045-A459-41EA617730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28283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E989BDD-EB29-402A-81D8-62C04E902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E5F4E769-14FD-4837-9469-F1A4ECB74D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9DEBCFF-DCFE-4C3B-8BDB-DAEE28E38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D6884EFB-CD10-4E99-87F7-FF58194E5E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CE72EAE-D36B-400B-9984-8C4E8D3C4B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83190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59522872-5DD8-4575-8A43-9BCB1E4BD00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0EBFBA45-C405-4500-824C-AC8ED7937BB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13DEF058-E545-4F5D-8332-C8F60EE6F0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F90F38D-7BF8-47CD-BE4F-9D12ECDA17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143B5C3-615B-4A11-BEA0-ADEC956768C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2016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8899F5D0-897D-4479-833F-723B58E547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544F6C9F-28A0-4014-B7B8-3B9B3A7F70C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2CC4587-1B74-4A3F-A9FC-F4CEECED5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838E312-70BE-4834-88CE-224D8D279A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7C295EA-00BF-401F-AC9D-58E4B7CEBE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444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C6798A0-7B0B-401F-BB99-C9CAFD5239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2187AED-02F0-4309-A76B-2EA2DB9E825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4DA5A432-8349-4F74-963D-2E155D2444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FE881F65-7C9B-4159-BDAA-75C2492435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DA872D0E-8125-4045-BF8F-BD6398C425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13175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F736616-C849-42C6-A792-2DD0456DE3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F4E9A372-41DD-450C-9F63-2A614AEAAC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36CFA51D-634F-4E98-B0AD-5688C8F79C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8B688D9-2015-4E82-AF1E-37B2FDB8DF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8C9BBCD-5399-44FB-94DE-7B33874CD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2010E4C-A5EC-4458-B391-ED49223E11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6461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C771DFBD-962A-4269-AA34-CB33BD62760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AEE028C2-9342-4BDD-ADCE-90BF5C311B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73D00FAD-396A-4AB4-AB47-DA39B5950FC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CDFBB49A-ECCF-47AD-BB07-97487D66DE8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51A2AA96-7EF0-4795-B6B0-E771A363751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4D97CC1F-6252-4877-91CD-2FEEACF1CE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BC1E5770-60A4-4773-BF1D-FA85286902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9D2D8870-09D1-4ED1-AE53-31648D816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898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C2DF21E-A38E-4D32-A98D-5171354951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BDFA6FA4-947E-4404-9CAB-B6DD250F3B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464825D2-BD48-4603-8C64-17954B6966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82C8E79A-24A9-4E79-8930-F030F3ADF2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0264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D277C4F3-9BFA-4E5E-AA43-449001E9AB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3008F281-6FE7-4D1D-BC09-64D125648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818DB8D6-197B-48AE-88FB-D63AA6243C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0937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4746B089-7610-4DC3-910C-19B03811C8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F1BF7DA-049A-482F-BF58-6DC0E6EB5E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8FA5CB4A-EC91-4BEE-82EC-51D68611A4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2AADEE8F-701A-4D36-8EEB-FD559C903B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BAFDD37F-FD77-446E-9379-D279D697A8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716BFEE2-229D-4AF0-828E-1473736D6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9023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9A605FD7-E884-4F42-896B-6BB8E9C4F7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F06191D0-7500-42D0-AC9C-609D76A7A5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F165B4E1-46CB-4D37-AD88-993B2C6FCE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4E8F75B3-2C0A-4BAC-8558-7212917E96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C65DB716-884B-4589-ACB1-0B94502378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D869388-8838-43FB-BCF6-ED263FE16F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3545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9A8C47C3-0972-4BC1-82D0-63B1AE9F04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E6365E8-CFF7-4513-ADF1-9C9B5DF793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8D0105F1-68E7-4CF7-926F-79252E8B976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B9F089-5849-4CB6-9449-778EC9F949BF}" type="datetimeFigureOut">
              <a:rPr lang="en-US" smtClean="0"/>
              <a:t>11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4BB3C3A4-C458-4F48-8B9D-A867BB3811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EA3C912-536E-4A5C-9745-2AF3F2942D3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2591A-95E9-40AC-9708-E2FED07AC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0163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FEC512DF-C1F5-42EA-ADA2-919A726120FC}"/>
              </a:ext>
            </a:extLst>
          </p:cNvPr>
          <p:cNvSpPr txBox="1"/>
          <p:nvPr/>
        </p:nvSpPr>
        <p:spPr>
          <a:xfrm>
            <a:off x="99873" y="1299700"/>
            <a:ext cx="11032725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2860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 Linear relationship between NUE (kg dry matter</a:t>
            </a:r>
            <a:r>
              <a:rPr lang="hr-HR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kg</a:t>
            </a:r>
            <a:r>
              <a:rPr lang="hr-HR" sz="1200" b="1" baseline="300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1</a:t>
            </a:r>
            <a:r>
              <a:rPr lang="en-US" sz="1200" b="1" baseline="300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) and  (A) GPC (%), (B) </a:t>
            </a:r>
            <a:r>
              <a:rPr lang="en-US" sz="1200" b="1" dirty="0" err="1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UpE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%), (C) </a:t>
            </a:r>
            <a:r>
              <a:rPr lang="en-US" sz="1200" b="1" dirty="0" err="1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NUtE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(kg dry matter</a:t>
            </a:r>
            <a:r>
              <a:rPr lang="hr-HR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kg</a:t>
            </a:r>
            <a:r>
              <a:rPr lang="hr-HR" sz="1200" b="1" baseline="300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-1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N) BLUP values under LN and HN. Each number represents a discrete cultivar (based on the list in Supplementary Table 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hr-HR" sz="1200" b="1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US" sz="1200" dirty="0" smtClean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 </a:t>
            </a:r>
          </a:p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hr-HR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 </a:t>
            </a:r>
            <a:endParaRPr lang="en-US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59937" y="2718486"/>
            <a:ext cx="1820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r-H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NUE vs. GPC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160998" y="2718486"/>
            <a:ext cx="1820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r-H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NUE vs. </a:t>
            </a:r>
            <a:r>
              <a:rPr lang="hr-H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p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8290938" y="2718486"/>
            <a:ext cx="1820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r-H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C) NUE vs. </a:t>
            </a:r>
            <a:r>
              <a:rPr lang="hr-H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t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366146"/>
            <a:ext cx="4149022" cy="2625469"/>
          </a:xfrm>
          <a:prstGeom prst="rect">
            <a:avLst/>
          </a:prstGeom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99650" y="3366146"/>
            <a:ext cx="4064010" cy="2625470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28003" y="3366146"/>
            <a:ext cx="4064010" cy="26254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51044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xmlns="" id="{ED7899B3-5D9D-45EF-A472-2399F2B935E6}"/>
              </a:ext>
            </a:extLst>
          </p:cNvPr>
          <p:cNvSpPr txBox="1"/>
          <p:nvPr/>
        </p:nvSpPr>
        <p:spPr>
          <a:xfrm>
            <a:off x="616892" y="1129156"/>
            <a:ext cx="1129867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2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 Linear relationship between (A) </a:t>
            </a:r>
            <a:r>
              <a:rPr lang="en-US" sz="1200" b="1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UpE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(%) and  GPC (%) and (B) </a:t>
            </a:r>
            <a:r>
              <a:rPr lang="en-US" sz="1200" b="1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UtE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(kg dry matter</a:t>
            </a:r>
            <a:r>
              <a:rPr lang="hr-HR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kg</a:t>
            </a:r>
            <a:r>
              <a:rPr lang="hr-HR" sz="1200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-1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N) BLUP values under LN and HN. Each number represents a discrete cultivar (based on the list in Supplementary Table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hr-HR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  </a:t>
            </a:r>
          </a:p>
          <a:p>
            <a:pPr algn="just"/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 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34294" y="2718486"/>
            <a:ext cx="1820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r-H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A) </a:t>
            </a:r>
            <a:r>
              <a:rPr lang="hr-H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pE</a:t>
            </a:r>
            <a:r>
              <a:rPr lang="hr-H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s. GPC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6409484" y="2718486"/>
            <a:ext cx="18205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hr-H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B) </a:t>
            </a:r>
            <a:r>
              <a:rPr lang="hr-H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pE</a:t>
            </a:r>
            <a:r>
              <a:rPr lang="hr-H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s. </a:t>
            </a:r>
            <a:r>
              <a:rPr lang="hr-H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UtE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892" y="3225482"/>
            <a:ext cx="5070298" cy="3109783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78702" y="3225482"/>
            <a:ext cx="5070298" cy="31097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43191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0C613AA-AE58-440C-896C-AA5A2946BF4E}"/>
              </a:ext>
            </a:extLst>
          </p:cNvPr>
          <p:cNvSpPr txBox="1"/>
          <p:nvPr/>
        </p:nvSpPr>
        <p:spPr>
          <a:xfrm>
            <a:off x="486263" y="682841"/>
            <a:ext cx="1133562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Supplementary Figure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3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 Linear relationship between </a:t>
            </a:r>
            <a:r>
              <a:rPr lang="en-US" sz="1200" b="1" dirty="0" err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NUtE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(kg dry matter</a:t>
            </a:r>
            <a:r>
              <a:rPr lang="hr-HR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kg</a:t>
            </a:r>
            <a:r>
              <a:rPr lang="hr-HR" sz="1200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-1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 N) and GPC (%) BLUP values. Each number represents a discrete cultivar (based on the list in Supplementary </a:t>
            </a:r>
            <a:r>
              <a:rPr lang="en-US" sz="1200" b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Table </a:t>
            </a:r>
            <a:r>
              <a:rPr lang="en-US" sz="1200" b="1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1</a:t>
            </a:r>
            <a:r>
              <a:rPr lang="en-US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)</a:t>
            </a:r>
            <a:r>
              <a:rPr lang="hr-HR" sz="12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.</a:t>
            </a:r>
            <a:r>
              <a:rPr lang="en-US" sz="1200" dirty="0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</a:rPr>
              <a:t> </a:t>
            </a:r>
            <a:endParaRPr lang="en-US" sz="1200" dirty="0">
              <a:solidFill>
                <a:srgbClr val="000000"/>
              </a:solidFill>
              <a:latin typeface="Times New Roman" panose="02020603050405020304" pitchFamily="18" charset="0"/>
              <a:ea typeface="Calibri" panose="020F0502020204030204" pitchFamily="34" charset="0"/>
            </a:endParaRP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9277" y="2085975"/>
            <a:ext cx="6476562" cy="39722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2846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</TotalTime>
  <Words>189</Words>
  <Application>Microsoft Office PowerPoint</Application>
  <PresentationFormat>Widescreen</PresentationFormat>
  <Paragraphs>1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NTLEY, Alison (CIMMYT)</dc:creator>
  <cp:lastModifiedBy>Dario</cp:lastModifiedBy>
  <cp:revision>38</cp:revision>
  <dcterms:created xsi:type="dcterms:W3CDTF">2020-12-31T12:56:19Z</dcterms:created>
  <dcterms:modified xsi:type="dcterms:W3CDTF">2021-11-02T19:46:15Z</dcterms:modified>
</cp:coreProperties>
</file>